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102" autoAdjust="0"/>
    <p:restoredTop sz="94660"/>
  </p:normalViewPr>
  <p:slideViewPr>
    <p:cSldViewPr snapToGrid="0">
      <p:cViewPr varScale="1">
        <p:scale>
          <a:sx n="93" d="100"/>
          <a:sy n="93" d="100"/>
        </p:scale>
        <p:origin x="96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645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1857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8950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9718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340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32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1492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2313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665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0351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7514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6A099-341D-46AF-992A-271E837E60DC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15F759-4C6B-4129-9B00-66B526B925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545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6002947"/>
              </p:ext>
            </p:extLst>
          </p:nvPr>
        </p:nvGraphicFramePr>
        <p:xfrm>
          <a:off x="743168" y="1590243"/>
          <a:ext cx="10800521" cy="289560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091478">
                  <a:extLst>
                    <a:ext uri="{9D8B030D-6E8A-4147-A177-3AD203B41FA5}">
                      <a16:colId xmlns:a16="http://schemas.microsoft.com/office/drawing/2014/main" val="3800255187"/>
                    </a:ext>
                  </a:extLst>
                </a:gridCol>
                <a:gridCol w="921990">
                  <a:extLst>
                    <a:ext uri="{9D8B030D-6E8A-4147-A177-3AD203B41FA5}">
                      <a16:colId xmlns:a16="http://schemas.microsoft.com/office/drawing/2014/main" val="1696094070"/>
                    </a:ext>
                  </a:extLst>
                </a:gridCol>
                <a:gridCol w="1232518">
                  <a:extLst>
                    <a:ext uri="{9D8B030D-6E8A-4147-A177-3AD203B41FA5}">
                      <a16:colId xmlns:a16="http://schemas.microsoft.com/office/drawing/2014/main" val="4131880467"/>
                    </a:ext>
                  </a:extLst>
                </a:gridCol>
                <a:gridCol w="784329">
                  <a:extLst>
                    <a:ext uri="{9D8B030D-6E8A-4147-A177-3AD203B41FA5}">
                      <a16:colId xmlns:a16="http://schemas.microsoft.com/office/drawing/2014/main" val="4235547881"/>
                    </a:ext>
                  </a:extLst>
                </a:gridCol>
                <a:gridCol w="1124781">
                  <a:extLst>
                    <a:ext uri="{9D8B030D-6E8A-4147-A177-3AD203B41FA5}">
                      <a16:colId xmlns:a16="http://schemas.microsoft.com/office/drawing/2014/main" val="2400719506"/>
                    </a:ext>
                  </a:extLst>
                </a:gridCol>
                <a:gridCol w="781878">
                  <a:extLst>
                    <a:ext uri="{9D8B030D-6E8A-4147-A177-3AD203B41FA5}">
                      <a16:colId xmlns:a16="http://schemas.microsoft.com/office/drawing/2014/main" val="513460482"/>
                    </a:ext>
                  </a:extLst>
                </a:gridCol>
                <a:gridCol w="1172817">
                  <a:extLst>
                    <a:ext uri="{9D8B030D-6E8A-4147-A177-3AD203B41FA5}">
                      <a16:colId xmlns:a16="http://schemas.microsoft.com/office/drawing/2014/main" val="2245759597"/>
                    </a:ext>
                  </a:extLst>
                </a:gridCol>
                <a:gridCol w="468382">
                  <a:extLst>
                    <a:ext uri="{9D8B030D-6E8A-4147-A177-3AD203B41FA5}">
                      <a16:colId xmlns:a16="http://schemas.microsoft.com/office/drawing/2014/main" val="1350598645"/>
                    </a:ext>
                  </a:extLst>
                </a:gridCol>
                <a:gridCol w="677932">
                  <a:extLst>
                    <a:ext uri="{9D8B030D-6E8A-4147-A177-3AD203B41FA5}">
                      <a16:colId xmlns:a16="http://schemas.microsoft.com/office/drawing/2014/main" val="3324309156"/>
                    </a:ext>
                  </a:extLst>
                </a:gridCol>
                <a:gridCol w="742121">
                  <a:extLst>
                    <a:ext uri="{9D8B030D-6E8A-4147-A177-3AD203B41FA5}">
                      <a16:colId xmlns:a16="http://schemas.microsoft.com/office/drawing/2014/main" val="3329555544"/>
                    </a:ext>
                  </a:extLst>
                </a:gridCol>
                <a:gridCol w="854765">
                  <a:extLst>
                    <a:ext uri="{9D8B030D-6E8A-4147-A177-3AD203B41FA5}">
                      <a16:colId xmlns:a16="http://schemas.microsoft.com/office/drawing/2014/main" val="2574084134"/>
                    </a:ext>
                  </a:extLst>
                </a:gridCol>
                <a:gridCol w="947530">
                  <a:extLst>
                    <a:ext uri="{9D8B030D-6E8A-4147-A177-3AD203B41FA5}">
                      <a16:colId xmlns:a16="http://schemas.microsoft.com/office/drawing/2014/main" val="68624589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ordinate (GRCh37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cript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GVS Nomenclatur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sequenc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Domain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FT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yphen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RP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omAD</a:t>
                      </a:r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F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 smtClean="0"/>
                        <a:t>MIM #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 smtClean="0"/>
                        <a:t>Relevant Evidence Categories*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 smtClean="0"/>
                        <a:t>Classification*</a:t>
                      </a:r>
                      <a:endParaRPr lang="en-GB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252822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3:41267300-412673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90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NNB1 c.884C&gt;G p.(Ala295Gly)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adill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eterious (0.01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sibly</a:t>
                      </a:r>
                      <a:r>
                        <a:rPr lang="en-GB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maging (0.68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114500, 617572, 114550,</a:t>
                      </a:r>
                      <a:r>
                        <a:rPr lang="en-GB" sz="1000" baseline="0" dirty="0" smtClean="0"/>
                        <a:t> 155255, 615075, 167000, 132600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PM2,</a:t>
                      </a:r>
                      <a:r>
                        <a:rPr lang="en-GB" sz="1000" baseline="0" dirty="0" smtClean="0"/>
                        <a:t> PP1</a:t>
                      </a:r>
                      <a:r>
                        <a:rPr lang="en-GB" sz="1000" dirty="0" smtClean="0"/>
                        <a:t>, PP2, PP3, PP4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Likely pathogenic</a:t>
                      </a:r>
                      <a:endParaRPr lang="en-GB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918358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8:71036933-7103693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132170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OA2 c.1348G&gt;A p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(Val450Met)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lerated</a:t>
                      </a:r>
                    </a:p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0.07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sibly damaging (0.788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-</a:t>
                      </a:r>
                    </a:p>
                    <a:p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PM2, BP4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Uncertain significance</a:t>
                      </a:r>
                      <a:endParaRPr lang="en-GB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536104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8:82572850-825728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553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A1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619G&gt;A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(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207Arg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ositol </a:t>
                      </a:r>
                      <a:r>
                        <a:rPr lang="en-GB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nophosphata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lerated</a:t>
                      </a:r>
                    </a:p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0.37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bably</a:t>
                      </a:r>
                      <a:r>
                        <a:rPr lang="en-GB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maging (1.0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	0.0000199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617323</a:t>
                      </a:r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PM2, BP4</a:t>
                      </a:r>
                    </a:p>
                    <a:p>
                      <a:endParaRPr lang="en-GB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Uncertain significanc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33736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21:43529677-435296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17356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MODL1 c.1525G&gt;A p.(Asp509Asn)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en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F-like domain</a:t>
                      </a:r>
                    </a:p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lerated</a:t>
                      </a:r>
                    </a:p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0.4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nign (0.174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4</a:t>
                      </a:r>
                    </a:p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00810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GB" sz="1000" dirty="0" smtClean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PM2, BP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Uncertain significanc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462372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68252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0</TotalTime>
  <Words>155</Words>
  <Application>Microsoft Office PowerPoint</Application>
  <PresentationFormat>Widescreen</PresentationFormat>
  <Paragraphs>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Taylor</dc:creator>
  <cp:lastModifiedBy>Rachel Taylor</cp:lastModifiedBy>
  <cp:revision>19</cp:revision>
  <dcterms:created xsi:type="dcterms:W3CDTF">2021-04-15T12:48:55Z</dcterms:created>
  <dcterms:modified xsi:type="dcterms:W3CDTF">2021-06-10T16:43:16Z</dcterms:modified>
</cp:coreProperties>
</file>